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5">
  <p:sldMasterIdLst>
    <p:sldMasterId id="2147483648" r:id="rId4"/>
  </p:sldMasterIdLst>
  <p:notesMasterIdLst>
    <p:notesMasterId r:id="rId6"/>
  </p:notesMasterIdLst>
  <p:sldIdLst>
    <p:sldId id="31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A31C418-18D7-FC01-4DB0-DB8C5F15C850}" name="Aziana Abu Hassan" initials="AAH" userId="Aziana Abu Hassan" providerId="None"/>
  <p188:author id="{307D5664-BCA0-BEA9-4FF5-496CF704CFAE}" name="Marko Hanzevacki (staff)" initials="MH(" userId="Marko Hanzevacki (staff)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E1EFA"/>
    <a:srgbClr val="FFA000"/>
    <a:srgbClr val="02FF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465" autoAdjust="0"/>
    <p:restoredTop sz="85830" autoAdjust="0"/>
  </p:normalViewPr>
  <p:slideViewPr>
    <p:cSldViewPr snapToGrid="0">
      <p:cViewPr varScale="1">
        <p:scale>
          <a:sx n="96" d="100"/>
          <a:sy n="96" d="100"/>
        </p:scale>
        <p:origin x="15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ca Pordea (staff)" userId="04217c9e-4602-4538-8d25-5638668eb9f5" providerId="ADAL" clId="{BDC62E32-F473-4E51-82DA-372116A5CA8E}"/>
    <pc:docChg chg="undo custSel addSld delSld">
      <pc:chgData name="Anca Pordea (staff)" userId="04217c9e-4602-4538-8d25-5638668eb9f5" providerId="ADAL" clId="{BDC62E32-F473-4E51-82DA-372116A5CA8E}" dt="2023-12-18T19:08:54.281" v="4" actId="47"/>
      <pc:docMkLst>
        <pc:docMk/>
      </pc:docMkLst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2773720066" sldId="256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2406690983" sldId="257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3309942647" sldId="258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256002129" sldId="262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2051766301" sldId="263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1729401590" sldId="264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1128189669" sldId="265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3808561837" sldId="266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3005349361" sldId="267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290462980" sldId="268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1479637886" sldId="271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2232706692" sldId="277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2441496266" sldId="278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1672111689" sldId="279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2141721781" sldId="280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341255541" sldId="281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2272614583" sldId="285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751480510" sldId="288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259477596" sldId="289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1090511444" sldId="290"/>
        </pc:sldMkLst>
      </pc:sldChg>
      <pc:sldChg chg="add del">
        <pc:chgData name="Anca Pordea (staff)" userId="04217c9e-4602-4538-8d25-5638668eb9f5" providerId="ADAL" clId="{BDC62E32-F473-4E51-82DA-372116A5CA8E}" dt="2023-12-18T19:08:54.281" v="4" actId="47"/>
        <pc:sldMkLst>
          <pc:docMk/>
          <pc:sldMk cId="3804230355" sldId="293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1079981970" sldId="294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3567409985" sldId="295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446155509" sldId="297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1702511720" sldId="298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4077862176" sldId="299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4281819590" sldId="301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532461093" sldId="302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825408573" sldId="305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3567219672" sldId="306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3023848852" sldId="308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292132675" sldId="309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2165866896" sldId="310"/>
        </pc:sldMkLst>
      </pc:sldChg>
      <pc:sldChg chg="add del">
        <pc:chgData name="Anca Pordea (staff)" userId="04217c9e-4602-4538-8d25-5638668eb9f5" providerId="ADAL" clId="{BDC62E32-F473-4E51-82DA-372116A5CA8E}" dt="2023-12-18T19:08:19.086" v="2" actId="47"/>
        <pc:sldMkLst>
          <pc:docMk/>
          <pc:sldMk cId="3892218898" sldId="311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3710938837" sldId="312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3756588774" sldId="314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1331867037" sldId="315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351316601" sldId="316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2026450018" sldId="317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1156295227" sldId="318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243933656" sldId="319"/>
        </pc:sldMkLst>
      </pc:sldChg>
      <pc:sldChg chg="add del">
        <pc:chgData name="Anca Pordea (staff)" userId="04217c9e-4602-4538-8d25-5638668eb9f5" providerId="ADAL" clId="{BDC62E32-F473-4E51-82DA-372116A5CA8E}" dt="2023-12-18T19:08:31.318" v="3" actId="47"/>
        <pc:sldMkLst>
          <pc:docMk/>
          <pc:sldMk cId="2633288119" sldId="320"/>
        </pc:sldMkLst>
      </pc:sldChg>
      <pc:sldChg chg="del">
        <pc:chgData name="Anca Pordea (staff)" userId="04217c9e-4602-4538-8d25-5638668eb9f5" providerId="ADAL" clId="{BDC62E32-F473-4E51-82DA-372116A5CA8E}" dt="2023-12-18T19:08:08.637" v="0" actId="47"/>
        <pc:sldMkLst>
          <pc:docMk/>
          <pc:sldMk cId="95252591" sldId="32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86DAC8-0F5C-40C4-9048-03E5F0338584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82B562-5671-4D39-9920-23E3852B6F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84031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GB" sz="1800" b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2 Table. Docking solutions obtained from rigid docking within GOLD software. </a:t>
            </a:r>
            <a:r>
              <a:rPr lang="en-GB" sz="1800" b="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olutions are ranked based on the fitness score from highest to lowest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82B562-5671-4D39-9920-23E3852B6FD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7288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839CC-2F4F-9676-481C-A8C6BD60D3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B78B30-6C9E-9383-5A22-347469CEE2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CF3B91-4E34-CF19-361A-C8592EC86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C2D85-0EFD-F1E1-E255-D409A42D7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04A4AE-7753-7C00-721D-98EB26BA0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339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1454C2-05D2-40B2-C98F-42188163E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A9FF01-EC14-452C-3CE0-F69E790709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EE166A-724F-0654-6132-EB6D136E6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5865FF-D369-A9FB-BE86-F396D4D2E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AD3664-4433-2CAF-0724-6D43A5EDC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9828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E88ECF-540D-9D8B-AA3D-0BFBCF95FB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DF5B47-A83B-3433-E305-0968F562A8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44D5D9-63A2-6610-C517-62DD48C0F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B9AA1-97FE-DF9C-A3CB-5C208B826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75377F-1DCC-3F4C-1493-4EB469A4B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912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743F2-CAC8-CCE5-22CC-8CCBCD2DF0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F9F779-89A1-544A-951D-A892F041EA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29A8DE-F0E3-F7D3-F0D4-FF0540892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D0439-C25F-AD3D-FB4B-F9C044F03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C2FB56-DEEF-B1EC-BB2B-6B06B28E5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6120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D81C7-B648-ECBB-EB5A-190AA87800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B8D037-CFF8-3CAE-B59F-42FF4DE911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D3928D-3201-D840-2A36-11982338F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EDBB0-1CBA-B1A9-36C6-CD364295E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EEA93A-115B-D044-5063-CCA7ACB1C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7324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8D1655-2CC5-8A36-679E-B66A3C818B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E9BB75-23E1-8048-21F0-8291ADA465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1A3F4A-1C5D-7B02-8B21-9555A35726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4E35E8-F04A-5333-D410-00E243298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A075AA-CC28-DF86-0F94-4D99C3AC99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BFF910-1687-8D7A-1E60-FB4E3700E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942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6B51B-A49C-DB81-129D-770B7B81E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3D9DB3-E956-030A-1DF5-3FB9D03B44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D2E3A9-FCD4-5AFE-85C4-F8F4DDA715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A0BCEB-5EF9-7EE9-599C-6B94A4674A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392368-689C-6BF0-C77F-0FC8D9730B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521DC13-1D6B-88D7-E33B-841299F68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1249E9-F2D9-4CE8-E6E4-69784C915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5DCCF0F-0559-9B9A-9D3B-F937169A2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448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E970B-DA53-0A74-ECA7-73762CEB39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514DDAA-CD12-6445-0D2D-6426A9B8D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E4ED273-A5E0-4AA0-9FB8-376853020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24533B-EB08-5EF6-12E6-A61B91BB1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3049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CCA8A7-6C30-3E41-FDA4-305B64DA9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98FDF7-8B82-C3B9-B1D3-F8A0D4019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6B7E57B-3FA1-1E79-D470-B0A644558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1219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6032A7-73AA-3738-F12D-A9F0F15F7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F9093D-A355-AE1D-2978-2A67002740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DE4AE4-E591-8AD3-0D49-79DAC0AD2F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8C028F-B9A0-811D-83B5-8780FC264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1EC2C9-44C6-5DDA-05D2-3CBF197BF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4A6038-8120-45EA-B5FE-EDC53B703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9556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9EFBDF-8326-737F-3DE1-8A0F176EF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75A8341-5D99-22B5-5588-0F213643C6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1F0F35-0A56-8640-3CB0-13C12B4769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94D0A3-D271-0D2E-F074-B7ACC0632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72C26D-735A-EDE8-811B-C6F37C007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1E86F7-F0E0-0A6F-02B3-303AB6C43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2666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F7FA97-498A-322A-7FC1-14CEFA006F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C761D6-4CC6-BD9F-31FF-4C66405D9E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92A81E-83E9-C733-B6FA-CCC1763CC7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D18AAE-C4F2-C908-CFD8-36D483C0CB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562CB5-FAC8-96AE-9FC4-FD1DF197A0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404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D752DC7-EF01-C2C1-4F24-85246F1185E5}"/>
              </a:ext>
            </a:extLst>
          </p:cNvPr>
          <p:cNvGraphicFramePr>
            <a:graphicFrameLocks noGrp="1"/>
          </p:cNvGraphicFramePr>
          <p:nvPr/>
        </p:nvGraphicFramePr>
        <p:xfrm>
          <a:off x="3355774" y="1825621"/>
          <a:ext cx="5480451" cy="4351347"/>
        </p:xfrm>
        <a:graphic>
          <a:graphicData uri="http://schemas.openxmlformats.org/drawingml/2006/table">
            <a:tbl>
              <a:tblPr firstRow="1" firstCol="1" bandRow="1"/>
              <a:tblGrid>
                <a:gridCol w="792055">
                  <a:extLst>
                    <a:ext uri="{9D8B030D-6E8A-4147-A177-3AD203B41FA5}">
                      <a16:colId xmlns:a16="http://schemas.microsoft.com/office/drawing/2014/main" val="446274936"/>
                    </a:ext>
                  </a:extLst>
                </a:gridCol>
                <a:gridCol w="1112974">
                  <a:extLst>
                    <a:ext uri="{9D8B030D-6E8A-4147-A177-3AD203B41FA5}">
                      <a16:colId xmlns:a16="http://schemas.microsoft.com/office/drawing/2014/main" val="4246045449"/>
                    </a:ext>
                  </a:extLst>
                </a:gridCol>
                <a:gridCol w="1878959">
                  <a:extLst>
                    <a:ext uri="{9D8B030D-6E8A-4147-A177-3AD203B41FA5}">
                      <a16:colId xmlns:a16="http://schemas.microsoft.com/office/drawing/2014/main" val="1711130147"/>
                    </a:ext>
                  </a:extLst>
                </a:gridCol>
                <a:gridCol w="740534">
                  <a:extLst>
                    <a:ext uri="{9D8B030D-6E8A-4147-A177-3AD203B41FA5}">
                      <a16:colId xmlns:a16="http://schemas.microsoft.com/office/drawing/2014/main" val="4167890762"/>
                    </a:ext>
                  </a:extLst>
                </a:gridCol>
                <a:gridCol w="955929">
                  <a:extLst>
                    <a:ext uri="{9D8B030D-6E8A-4147-A177-3AD203B41FA5}">
                      <a16:colId xmlns:a16="http://schemas.microsoft.com/office/drawing/2014/main" val="2104218836"/>
                    </a:ext>
                  </a:extLst>
                </a:gridCol>
              </a:tblGrid>
              <a:tr h="37244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ank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itness Score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MY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=C unit number closest to Fe−O</a:t>
                      </a:r>
                      <a:r>
                        <a:rPr lang="en-MY" sz="1100" b="1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MY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complex</a:t>
                      </a: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  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</a:t>
                      </a:r>
                      <a:r>
                        <a:rPr lang="en-MY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istance of C=C to the oxygen atom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5105766"/>
                  </a:ext>
                </a:extLst>
              </a:tr>
              <a:tr h="186220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hemPLP docking protocol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H</a:t>
                      </a:r>
                      <a:r>
                        <a:rPr lang="en-MY" sz="1100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-C=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=C-CH</a:t>
                      </a:r>
                      <a:r>
                        <a:rPr lang="en-MY" sz="1100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1670441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.38  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3001237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1.1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.2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3691264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46.4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1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3174369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51.2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1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409536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53.86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6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2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3093977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57.6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6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2662519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60.2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.6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0427927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90.1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2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7713104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03.81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0932623"/>
                  </a:ext>
                </a:extLst>
              </a:tr>
              <a:tr h="1862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12.8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1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7618854"/>
                  </a:ext>
                </a:extLst>
              </a:tr>
              <a:tr h="18001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hemScore docking protocol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0618530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.56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9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6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8799693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.11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8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205459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.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8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330863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.2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3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2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219025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4142455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5824154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42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3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4450154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3.48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979496"/>
                  </a:ext>
                </a:extLst>
              </a:tr>
              <a:tr h="1800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7.52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8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889779"/>
                  </a:ext>
                </a:extLst>
              </a:tr>
              <a:tr h="1862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31.98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8</a:t>
                      </a:r>
                      <a:endParaRPr lang="en-MY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9" marR="6703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6394387"/>
                  </a:ext>
                </a:extLst>
              </a:tr>
            </a:tbl>
          </a:graphicData>
        </a:graphic>
      </p:graphicFrame>
      <p:sp>
        <p:nvSpPr>
          <p:cNvPr id="7" name="Rectangle 5">
            <a:extLst>
              <a:ext uri="{FF2B5EF4-FFF2-40B4-BE49-F238E27FC236}">
                <a16:creationId xmlns:a16="http://schemas.microsoft.com/office/drawing/2014/main" id="{87809EA3-6ACC-AF62-4A6A-FAD7697A96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55975" y="1825625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MY"/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F2C58A83-EC0D-66B7-B6DE-E9B1A82772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3927219"/>
              </p:ext>
            </p:extLst>
          </p:nvPr>
        </p:nvGraphicFramePr>
        <p:xfrm>
          <a:off x="3219449" y="825494"/>
          <a:ext cx="5753100" cy="666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8431814" imgH="959724" progId="ChemDraw.Document.6.0">
                  <p:embed/>
                </p:oleObj>
              </mc:Choice>
              <mc:Fallback>
                <p:oleObj name="CS ChemDraw Drawing" r:id="rId3" imgW="8431814" imgH="959724" progId="ChemDraw.Document.6.0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F2C58A83-EC0D-66B7-B6DE-E9B1A82772CF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19449" y="825494"/>
                        <a:ext cx="5753100" cy="6667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tangle 6">
            <a:extLst>
              <a:ext uri="{FF2B5EF4-FFF2-40B4-BE49-F238E27FC236}">
                <a16:creationId xmlns:a16="http://schemas.microsoft.com/office/drawing/2014/main" id="{9500CB72-6595-6FE3-3EAE-42724A3275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80179" y="6233346"/>
            <a:ext cx="6571796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000" b="0" i="0" u="none" strike="noStrike" cap="none" normalizeH="0" baseline="3000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kumimoji="0" lang="en-GB" altLang="en-US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first C=C unit number was counted from the end terminal with two methyl group R-C=C-(CH</a:t>
            </a:r>
            <a:r>
              <a:rPr kumimoji="0" lang="en-GB" altLang="en-US" sz="1000" b="0" i="0" u="none" strike="noStrike" cap="none" normalizeH="0" baseline="-3000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kumimoji="0" lang="en-GB" altLang="en-US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kumimoji="0" lang="en-GB" altLang="en-US" sz="1000" b="0" i="0" u="none" strike="noStrike" cap="none" normalizeH="0" baseline="-3000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 </a:t>
            </a:r>
            <a:r>
              <a:rPr kumimoji="0" lang="en-GB" altLang="en-US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</a:t>
            </a:r>
            <a:r>
              <a:rPr kumimoji="0" lang="en-GB" altLang="en-US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ee scheme; </a:t>
            </a:r>
            <a:r>
              <a:rPr kumimoji="0" lang="en-GB" altLang="en-US" sz="1000" b="0" i="0" u="none" strike="noStrike" cap="none" normalizeH="0" baseline="3000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kumimoji="0" lang="en-GB" altLang="en-US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distance was measured from each C atom in the double bond to the distal O atom of the Fe-O</a:t>
            </a:r>
            <a:r>
              <a:rPr kumimoji="0" lang="en-GB" altLang="en-US" sz="1000" b="0" i="0" u="none" strike="noStrike" cap="none" normalizeH="0" baseline="-3000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kumimoji="0" lang="en-GB" altLang="en-US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omplex</a:t>
            </a:r>
            <a:endParaRPr kumimoji="0" lang="en-GB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2218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c1e910d-4918-42f1-af2c-ed1101d63abc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7573F99DE79145B2C4B20841E12603" ma:contentTypeVersion="17" ma:contentTypeDescription="Create a new document." ma:contentTypeScope="" ma:versionID="75a924c6fce2bfbfdafe8aa5030a8127">
  <xsd:schema xmlns:xsd="http://www.w3.org/2001/XMLSchema" xmlns:xs="http://www.w3.org/2001/XMLSchema" xmlns:p="http://schemas.microsoft.com/office/2006/metadata/properties" xmlns:ns3="0c1e910d-4918-42f1-af2c-ed1101d63abc" xmlns:ns4="786e620f-b1da-4f59-878c-ef7546d25bf1" targetNamespace="http://schemas.microsoft.com/office/2006/metadata/properties" ma:root="true" ma:fieldsID="84345ca33903240b6bb317a7195b494d" ns3:_="" ns4:_="">
    <xsd:import namespace="0c1e910d-4918-42f1-af2c-ed1101d63abc"/>
    <xsd:import namespace="786e620f-b1da-4f59-878c-ef7546d25bf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c1e910d-4918-42f1-af2c-ed1101d63ab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3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6e620f-b1da-4f59-878c-ef7546d25bf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FF0F8F7-5F66-4883-BEC4-F64859C3F4BC}">
  <ds:schemaRefs>
    <ds:schemaRef ds:uri="http://www.w3.org/XML/1998/namespace"/>
    <ds:schemaRef ds:uri="http://purl.org/dc/terms/"/>
    <ds:schemaRef ds:uri="http://schemas.microsoft.com/office/2006/metadata/properties"/>
    <ds:schemaRef ds:uri="0c1e910d-4918-42f1-af2c-ed1101d63abc"/>
    <ds:schemaRef ds:uri="786e620f-b1da-4f59-878c-ef7546d25bf1"/>
    <ds:schemaRef ds:uri="http://purl.org/dc/dcmitype/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F56DA7E7-3482-4CEA-AA13-D1276F6BD35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c1e910d-4918-42f1-af2c-ed1101d63abc"/>
    <ds:schemaRef ds:uri="786e620f-b1da-4f59-878c-ef7546d25bf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8BC3993-CD11-46D5-AFD3-539F9D1D026D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414</TotalTime>
  <Words>222</Words>
  <Application>Microsoft Office PowerPoint</Application>
  <PresentationFormat>Widescreen</PresentationFormat>
  <Paragraphs>111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CS ChemDraw Drawing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o Hanzevacki (staff)</dc:creator>
  <cp:lastModifiedBy>Anca Pordea (staff)</cp:lastModifiedBy>
  <cp:revision>365</cp:revision>
  <dcterms:created xsi:type="dcterms:W3CDTF">2022-09-23T18:06:25Z</dcterms:created>
  <dcterms:modified xsi:type="dcterms:W3CDTF">2023-12-18T19:08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7573F99DE79145B2C4B20841E12603</vt:lpwstr>
  </property>
</Properties>
</file>